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5439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2441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7711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6851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5755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9517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1615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360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022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0986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1592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47E88-2AD6-44E9-AD6E-55551BF8D03D}" type="datetimeFigureOut">
              <a:rPr lang="de-DE" smtClean="0"/>
              <a:t>03.10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46723-1A21-4FDF-83A4-3D99F72B92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428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18360" y="188640"/>
            <a:ext cx="53126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 Table. MMP-2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cending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ortic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mete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2782142"/>
              </p:ext>
            </p:extLst>
          </p:nvPr>
        </p:nvGraphicFramePr>
        <p:xfrm>
          <a:off x="179512" y="476672"/>
          <a:ext cx="4343398" cy="43723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0278"/>
                <a:gridCol w="850278"/>
                <a:gridCol w="850278"/>
                <a:gridCol w="850278"/>
                <a:gridCol w="942286"/>
              </a:tblGrid>
              <a:tr h="396973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 err="1" smtClean="0">
                          <a:effectLst/>
                        </a:rPr>
                        <a:t>tissue</a:t>
                      </a:r>
                      <a:r>
                        <a:rPr lang="de-DE" sz="1000" b="1" u="none" strike="noStrike" dirty="0" smtClean="0">
                          <a:effectLst/>
                        </a:rPr>
                        <a:t> pro-MMP-2   [AU]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>
                          <a:effectLst/>
                        </a:rPr>
                        <a:t>tissue active MMP-2   [AU]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>
                          <a:effectLst/>
                        </a:rPr>
                        <a:t>tissue total MMP-2   [AU]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 err="1">
                          <a:effectLst/>
                        </a:rPr>
                        <a:t>serum</a:t>
                      </a:r>
                      <a:r>
                        <a:rPr lang="de-DE" sz="1000" b="1" u="none" strike="noStrike" dirty="0">
                          <a:effectLst/>
                        </a:rPr>
                        <a:t> </a:t>
                      </a:r>
                      <a:r>
                        <a:rPr lang="de-DE" sz="1000" b="1" u="none" strike="noStrike" dirty="0" smtClean="0">
                          <a:effectLst/>
                        </a:rPr>
                        <a:t>MMP-2</a:t>
                      </a:r>
                      <a:r>
                        <a:rPr lang="de-DE" sz="1000" b="1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b="1" u="none" strike="noStrike" dirty="0" smtClean="0">
                          <a:effectLst/>
                        </a:rPr>
                        <a:t>[</a:t>
                      </a:r>
                      <a:r>
                        <a:rPr lang="de-DE" sz="1000" b="1" u="none" strike="noStrike" dirty="0" err="1" smtClean="0">
                          <a:effectLst/>
                        </a:rPr>
                        <a:t>ng</a:t>
                      </a:r>
                      <a:r>
                        <a:rPr lang="de-DE" sz="1000" b="1" u="none" strike="noStrike" dirty="0" smtClean="0">
                          <a:effectLst/>
                        </a:rPr>
                        <a:t>/ml]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 err="1">
                          <a:effectLst/>
                        </a:rPr>
                        <a:t>ascending</a:t>
                      </a:r>
                      <a:r>
                        <a:rPr lang="de-DE" sz="1000" b="1" u="none" strike="noStrike" dirty="0">
                          <a:effectLst/>
                        </a:rPr>
                        <a:t> </a:t>
                      </a:r>
                      <a:r>
                        <a:rPr lang="de-DE" sz="1000" b="1" u="none" strike="noStrike" dirty="0" err="1">
                          <a:effectLst/>
                        </a:rPr>
                        <a:t>aortic</a:t>
                      </a:r>
                      <a:r>
                        <a:rPr lang="de-DE" sz="1000" b="1" u="none" strike="noStrike" dirty="0">
                          <a:effectLst/>
                        </a:rPr>
                        <a:t> </a:t>
                      </a:r>
                      <a:r>
                        <a:rPr lang="de-DE" sz="1000" b="1" u="none" strike="noStrike" dirty="0" err="1">
                          <a:effectLst/>
                        </a:rPr>
                        <a:t>diameter</a:t>
                      </a:r>
                      <a:r>
                        <a:rPr lang="de-DE" sz="1000" b="1" u="none" strike="noStrike" dirty="0">
                          <a:effectLst/>
                        </a:rPr>
                        <a:t> [mm]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511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2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9.7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2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9.5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3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0.8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3.1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3.9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5.6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7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6.7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9.0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99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2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9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7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6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9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4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80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8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29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94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5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4.5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8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83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5.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3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66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6.4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3.0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5.2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5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2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9.8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2.0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7.6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9.5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9.6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3.9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1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1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6.7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98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9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8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0.3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1.1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91.4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6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3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6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7.8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3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32.1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0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3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0.4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03.9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30.0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8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8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4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2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6.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5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2.7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5.9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8.7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7.4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60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80.6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0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31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4.1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0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8.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4.5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13.1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94.5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1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7.2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8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5.3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78.5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2.6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9.3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2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1.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4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2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7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9.4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1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5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7.6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5.2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2.8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81.7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1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8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2.0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0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33.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62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3.4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.8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6.2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78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0</a:t>
                      </a: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68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8.7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7.5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9.4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3</a:t>
                      </a: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1716970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1</Words>
  <Application>Microsoft Office PowerPoint</Application>
  <PresentationFormat>Bildschirmpräsentation (4:3)</PresentationFormat>
  <Paragraphs>12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2</cp:revision>
  <dcterms:created xsi:type="dcterms:W3CDTF">2016-09-29T14:32:54Z</dcterms:created>
  <dcterms:modified xsi:type="dcterms:W3CDTF">2016-10-03T16:27:08Z</dcterms:modified>
</cp:coreProperties>
</file>